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sldIdLst>
    <p:sldId id="256" r:id="rId2"/>
  </p:sldIdLst>
  <p:sldSz cx="6480175" cy="63007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25" autoAdjust="0"/>
    <p:restoredTop sz="97436" autoAdjust="0"/>
  </p:normalViewPr>
  <p:slideViewPr>
    <p:cSldViewPr snapToGrid="0">
      <p:cViewPr varScale="1">
        <p:scale>
          <a:sx n="171" d="100"/>
          <a:sy n="171" d="100"/>
        </p:scale>
        <p:origin x="1476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031171"/>
            <a:ext cx="5508149" cy="2193608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3309373"/>
            <a:ext cx="4860131" cy="1521231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41859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25991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335458"/>
            <a:ext cx="1397288" cy="533962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335458"/>
            <a:ext cx="4110861" cy="533962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3669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62298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1570823"/>
            <a:ext cx="5589151" cy="2620952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4216571"/>
            <a:ext cx="5589151" cy="1378297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7388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1677293"/>
            <a:ext cx="2754074" cy="399779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1677293"/>
            <a:ext cx="2754074" cy="399779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76734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335460"/>
            <a:ext cx="5589151" cy="121786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1544569"/>
            <a:ext cx="2741417" cy="756969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2301538"/>
            <a:ext cx="2741417" cy="338521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1544569"/>
            <a:ext cx="2754918" cy="756969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2301538"/>
            <a:ext cx="2754918" cy="338521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4435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050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52503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20052"/>
            <a:ext cx="2090025" cy="1470184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907198"/>
            <a:ext cx="3280589" cy="4477643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890236"/>
            <a:ext cx="2090025" cy="350189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18588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20052"/>
            <a:ext cx="2090025" cy="1470184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907198"/>
            <a:ext cx="3280589" cy="4477643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890236"/>
            <a:ext cx="2090025" cy="350189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96745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335460"/>
            <a:ext cx="5589151" cy="121786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1677293"/>
            <a:ext cx="5589151" cy="39977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5839898"/>
            <a:ext cx="1458039" cy="3354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0/10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5839898"/>
            <a:ext cx="2187059" cy="3354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5839898"/>
            <a:ext cx="1458039" cy="3354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8698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3" Type="http://schemas.openxmlformats.org/officeDocument/2006/relationships/image" Target="../media/image2.emf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emf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19" Type="http://schemas.openxmlformats.org/officeDocument/2006/relationships/image" Target="../media/image18.emf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7" name="图片 106">
            <a:extLst>
              <a:ext uri="{FF2B5EF4-FFF2-40B4-BE49-F238E27FC236}">
                <a16:creationId xmlns:a16="http://schemas.microsoft.com/office/drawing/2014/main" id="{7AC2532C-1D16-4F02-A542-C940D9816A8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346" t="40782" r="6925" b="38505"/>
          <a:stretch/>
        </p:blipFill>
        <p:spPr>
          <a:xfrm>
            <a:off x="3438606" y="3645929"/>
            <a:ext cx="954468" cy="954468"/>
          </a:xfrm>
          <a:prstGeom prst="rect">
            <a:avLst/>
          </a:prstGeom>
        </p:spPr>
      </p:pic>
      <p:sp>
        <p:nvSpPr>
          <p:cNvPr id="52" name="文本框 51">
            <a:extLst>
              <a:ext uri="{FF2B5EF4-FFF2-40B4-BE49-F238E27FC236}">
                <a16:creationId xmlns:a16="http://schemas.microsoft.com/office/drawing/2014/main" id="{B58C4B78-C00E-4CCB-B0E0-FFEBD5FA7DD0}"/>
              </a:ext>
            </a:extLst>
          </p:cNvPr>
          <p:cNvSpPr txBox="1"/>
          <p:nvPr/>
        </p:nvSpPr>
        <p:spPr>
          <a:xfrm>
            <a:off x="131590" y="-19860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4617E6A1-3FE5-46A3-8A01-B80D3017628E}"/>
              </a:ext>
            </a:extLst>
          </p:cNvPr>
          <p:cNvSpPr txBox="1"/>
          <p:nvPr/>
        </p:nvSpPr>
        <p:spPr>
          <a:xfrm>
            <a:off x="-67371" y="714684"/>
            <a:ext cx="4699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P5D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9F0EA1CD-80F0-4CB8-AEC1-4BBE2323E1CC}"/>
              </a:ext>
            </a:extLst>
          </p:cNvPr>
          <p:cNvSpPr txBox="1"/>
          <p:nvPr/>
        </p:nvSpPr>
        <p:spPr>
          <a:xfrm>
            <a:off x="-67364" y="1701036"/>
            <a:ext cx="528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P14D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5785C4A6-6DE9-4E86-AFEC-1D5AB261929D}"/>
              </a:ext>
            </a:extLst>
          </p:cNvPr>
          <p:cNvSpPr txBox="1"/>
          <p:nvPr/>
        </p:nvSpPr>
        <p:spPr>
          <a:xfrm>
            <a:off x="879978" y="-12634"/>
            <a:ext cx="9544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Glomerulus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id="{4A5A772F-AC70-419E-AF1A-9F5596754C24}"/>
              </a:ext>
            </a:extLst>
          </p:cNvPr>
          <p:cNvCxnSpPr>
            <a:cxnSpLocks/>
          </p:cNvCxnSpPr>
          <p:nvPr/>
        </p:nvCxnSpPr>
        <p:spPr>
          <a:xfrm>
            <a:off x="546100" y="187975"/>
            <a:ext cx="16192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文本框 71">
            <a:extLst>
              <a:ext uri="{FF2B5EF4-FFF2-40B4-BE49-F238E27FC236}">
                <a16:creationId xmlns:a16="http://schemas.microsoft.com/office/drawing/2014/main" id="{539FFC00-7BC4-4D68-8950-7EA72F4B1BFD}"/>
              </a:ext>
            </a:extLst>
          </p:cNvPr>
          <p:cNvSpPr txBox="1"/>
          <p:nvPr/>
        </p:nvSpPr>
        <p:spPr>
          <a:xfrm>
            <a:off x="461520" y="153958"/>
            <a:ext cx="80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AE83F367-DFC0-4F75-8EEB-3C9A62503BDC}"/>
              </a:ext>
            </a:extLst>
          </p:cNvPr>
          <p:cNvSpPr txBox="1"/>
          <p:nvPr/>
        </p:nvSpPr>
        <p:spPr>
          <a:xfrm>
            <a:off x="1453802" y="149883"/>
            <a:ext cx="80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Hyperoxi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87A90F62-3E73-432F-8DF3-4AF5667AECD0}"/>
              </a:ext>
            </a:extLst>
          </p:cNvPr>
          <p:cNvSpPr txBox="1"/>
          <p:nvPr/>
        </p:nvSpPr>
        <p:spPr>
          <a:xfrm>
            <a:off x="2858392" y="-12634"/>
            <a:ext cx="1154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Proximal tubule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直接连接符 77">
            <a:extLst>
              <a:ext uri="{FF2B5EF4-FFF2-40B4-BE49-F238E27FC236}">
                <a16:creationId xmlns:a16="http://schemas.microsoft.com/office/drawing/2014/main" id="{BD07E4F3-129D-4E9F-9B61-9802827D8C91}"/>
              </a:ext>
            </a:extLst>
          </p:cNvPr>
          <p:cNvCxnSpPr>
            <a:cxnSpLocks/>
          </p:cNvCxnSpPr>
          <p:nvPr/>
        </p:nvCxnSpPr>
        <p:spPr>
          <a:xfrm>
            <a:off x="2600930" y="187975"/>
            <a:ext cx="16192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文本框 78">
            <a:extLst>
              <a:ext uri="{FF2B5EF4-FFF2-40B4-BE49-F238E27FC236}">
                <a16:creationId xmlns:a16="http://schemas.microsoft.com/office/drawing/2014/main" id="{176EFFCF-2FC6-4250-B4D8-96D9B029BB3C}"/>
              </a:ext>
            </a:extLst>
          </p:cNvPr>
          <p:cNvSpPr txBox="1"/>
          <p:nvPr/>
        </p:nvSpPr>
        <p:spPr>
          <a:xfrm>
            <a:off x="2516350" y="153959"/>
            <a:ext cx="80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B0FCCE0E-D456-4DBB-911C-B16D9DA50328}"/>
              </a:ext>
            </a:extLst>
          </p:cNvPr>
          <p:cNvSpPr txBox="1"/>
          <p:nvPr/>
        </p:nvSpPr>
        <p:spPr>
          <a:xfrm>
            <a:off x="3508631" y="149883"/>
            <a:ext cx="80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Hyperoxi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6" name="图片 165">
            <a:extLst>
              <a:ext uri="{FF2B5EF4-FFF2-40B4-BE49-F238E27FC236}">
                <a16:creationId xmlns:a16="http://schemas.microsoft.com/office/drawing/2014/main" id="{8E8FEC85-EF2F-4FF3-892E-7E07D550CF3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390950" y="544634"/>
            <a:ext cx="2276841" cy="1957194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8485003A-B7CA-4C1C-A4FE-552A50CE215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24" t="30551" r="52047" b="48736"/>
          <a:stretch/>
        </p:blipFill>
        <p:spPr>
          <a:xfrm>
            <a:off x="2440149" y="347995"/>
            <a:ext cx="954468" cy="954468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47F6BB65-432F-4A40-A67C-342519658BC0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43" t="57935" r="51028" b="21352"/>
          <a:stretch/>
        </p:blipFill>
        <p:spPr>
          <a:xfrm>
            <a:off x="3436473" y="353154"/>
            <a:ext cx="954475" cy="954475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06F0E179-D115-41F9-A39D-0566DF3DE718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8" t="29287" r="81363" b="50000"/>
          <a:stretch/>
        </p:blipFill>
        <p:spPr>
          <a:xfrm>
            <a:off x="375811" y="343838"/>
            <a:ext cx="954475" cy="954475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0CE73E25-5A40-4743-93C7-7E4F586FABAC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98" t="33021" r="55173" b="46266"/>
          <a:stretch/>
        </p:blipFill>
        <p:spPr>
          <a:xfrm>
            <a:off x="1384814" y="343833"/>
            <a:ext cx="954468" cy="954468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ED0444C8-5D98-40C9-9EC4-0675C1BF033C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31" t="26748" r="52140" b="52539"/>
          <a:stretch/>
        </p:blipFill>
        <p:spPr>
          <a:xfrm>
            <a:off x="375818" y="1346904"/>
            <a:ext cx="954468" cy="954468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A0D3FAAA-9413-420F-85AF-9B811A218997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050" t="47843" r="5221" b="31444"/>
          <a:stretch/>
        </p:blipFill>
        <p:spPr>
          <a:xfrm>
            <a:off x="1384821" y="1346904"/>
            <a:ext cx="954468" cy="954468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8BEC12AD-4191-439A-BB1A-A9FF93879DA3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85" t="51188" r="62186" b="28099"/>
          <a:stretch/>
        </p:blipFill>
        <p:spPr>
          <a:xfrm>
            <a:off x="2440149" y="1346904"/>
            <a:ext cx="954468" cy="954468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B206EB94-B214-4035-BD98-4930517E62F9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231" t="21514" r="8040" b="57773"/>
          <a:stretch/>
        </p:blipFill>
        <p:spPr>
          <a:xfrm>
            <a:off x="3436472" y="1353832"/>
            <a:ext cx="954468" cy="954468"/>
          </a:xfrm>
          <a:prstGeom prst="rect">
            <a:avLst/>
          </a:prstGeom>
        </p:spPr>
      </p:pic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D3CD629B-962C-4FF0-9E90-1CEFDC263483}"/>
              </a:ext>
            </a:extLst>
          </p:cNvPr>
          <p:cNvCxnSpPr/>
          <p:nvPr/>
        </p:nvCxnSpPr>
        <p:spPr>
          <a:xfrm>
            <a:off x="3992418" y="2114884"/>
            <a:ext cx="3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CBB8B6CD-5D54-4C94-B72C-8020172602A5}"/>
              </a:ext>
            </a:extLst>
          </p:cNvPr>
          <p:cNvSpPr txBox="1"/>
          <p:nvPr/>
        </p:nvSpPr>
        <p:spPr>
          <a:xfrm>
            <a:off x="3912041" y="2108297"/>
            <a:ext cx="52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r>
              <a:rPr lang="el-GR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" name="图片 46">
            <a:extLst>
              <a:ext uri="{FF2B5EF4-FFF2-40B4-BE49-F238E27FC236}">
                <a16:creationId xmlns:a16="http://schemas.microsoft.com/office/drawing/2014/main" id="{44E48320-83D7-4F28-9EAA-0392B571BBF7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35" t="17450" r="64936" b="61837"/>
          <a:stretch/>
        </p:blipFill>
        <p:spPr>
          <a:xfrm>
            <a:off x="375804" y="2668257"/>
            <a:ext cx="954476" cy="954476"/>
          </a:xfrm>
          <a:prstGeom prst="rect">
            <a:avLst/>
          </a:prstGeom>
        </p:spPr>
      </p:pic>
      <p:sp>
        <p:nvSpPr>
          <p:cNvPr id="86" name="文本框 85">
            <a:extLst>
              <a:ext uri="{FF2B5EF4-FFF2-40B4-BE49-F238E27FC236}">
                <a16:creationId xmlns:a16="http://schemas.microsoft.com/office/drawing/2014/main" id="{940A4FB0-2E03-4F99-BAA2-E4FF0010DAAF}"/>
              </a:ext>
            </a:extLst>
          </p:cNvPr>
          <p:cNvSpPr txBox="1"/>
          <p:nvPr/>
        </p:nvSpPr>
        <p:spPr>
          <a:xfrm>
            <a:off x="131590" y="2276700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9B2EA44E-EA95-4558-81BC-10B72EACD967}"/>
              </a:ext>
            </a:extLst>
          </p:cNvPr>
          <p:cNvSpPr txBox="1"/>
          <p:nvPr/>
        </p:nvSpPr>
        <p:spPr>
          <a:xfrm>
            <a:off x="-67371" y="3039117"/>
            <a:ext cx="4699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P5D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56CB1162-CB1E-4D54-BA96-B5A3899B85BB}"/>
              </a:ext>
            </a:extLst>
          </p:cNvPr>
          <p:cNvSpPr txBox="1"/>
          <p:nvPr/>
        </p:nvSpPr>
        <p:spPr>
          <a:xfrm>
            <a:off x="-67364" y="4025468"/>
            <a:ext cx="528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P14D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87ECE528-B368-4DF4-B3FD-FC271DD3B4C1}"/>
              </a:ext>
            </a:extLst>
          </p:cNvPr>
          <p:cNvSpPr txBox="1"/>
          <p:nvPr/>
        </p:nvSpPr>
        <p:spPr>
          <a:xfrm>
            <a:off x="879978" y="2283926"/>
            <a:ext cx="9544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Glomerulus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id="{68D52238-CBDA-436F-BA8B-9B30018A4869}"/>
              </a:ext>
            </a:extLst>
          </p:cNvPr>
          <p:cNvCxnSpPr>
            <a:cxnSpLocks/>
          </p:cNvCxnSpPr>
          <p:nvPr/>
        </p:nvCxnSpPr>
        <p:spPr>
          <a:xfrm>
            <a:off x="546100" y="2484527"/>
            <a:ext cx="16192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1" name="文本框 90">
            <a:extLst>
              <a:ext uri="{FF2B5EF4-FFF2-40B4-BE49-F238E27FC236}">
                <a16:creationId xmlns:a16="http://schemas.microsoft.com/office/drawing/2014/main" id="{5116ADB7-7BB6-4B03-AAC1-1D8F792C3E87}"/>
              </a:ext>
            </a:extLst>
          </p:cNvPr>
          <p:cNvSpPr txBox="1"/>
          <p:nvPr/>
        </p:nvSpPr>
        <p:spPr>
          <a:xfrm>
            <a:off x="461520" y="2450517"/>
            <a:ext cx="80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001B899B-BF53-4EA1-A755-C6BC3329DCFD}"/>
              </a:ext>
            </a:extLst>
          </p:cNvPr>
          <p:cNvSpPr txBox="1"/>
          <p:nvPr/>
        </p:nvSpPr>
        <p:spPr>
          <a:xfrm>
            <a:off x="1453802" y="2446442"/>
            <a:ext cx="80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Hyperoxi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DD8C7D2D-267D-4A04-9E30-7FF71386B384}"/>
              </a:ext>
            </a:extLst>
          </p:cNvPr>
          <p:cNvSpPr txBox="1"/>
          <p:nvPr/>
        </p:nvSpPr>
        <p:spPr>
          <a:xfrm>
            <a:off x="2858396" y="2283926"/>
            <a:ext cx="1154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Proximal tubule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4" name="直接连接符 93">
            <a:extLst>
              <a:ext uri="{FF2B5EF4-FFF2-40B4-BE49-F238E27FC236}">
                <a16:creationId xmlns:a16="http://schemas.microsoft.com/office/drawing/2014/main" id="{E0EFCE02-0192-417E-8A0A-7F6271257750}"/>
              </a:ext>
            </a:extLst>
          </p:cNvPr>
          <p:cNvCxnSpPr>
            <a:cxnSpLocks/>
          </p:cNvCxnSpPr>
          <p:nvPr/>
        </p:nvCxnSpPr>
        <p:spPr>
          <a:xfrm>
            <a:off x="2600930" y="2484527"/>
            <a:ext cx="16192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5" name="文本框 94">
            <a:extLst>
              <a:ext uri="{FF2B5EF4-FFF2-40B4-BE49-F238E27FC236}">
                <a16:creationId xmlns:a16="http://schemas.microsoft.com/office/drawing/2014/main" id="{6FAEA8B8-F546-4129-B85F-11C668E60600}"/>
              </a:ext>
            </a:extLst>
          </p:cNvPr>
          <p:cNvSpPr txBox="1"/>
          <p:nvPr/>
        </p:nvSpPr>
        <p:spPr>
          <a:xfrm>
            <a:off x="2516350" y="2450518"/>
            <a:ext cx="80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90BFA2D9-F9D8-4B66-9690-0590917C4CC7}"/>
              </a:ext>
            </a:extLst>
          </p:cNvPr>
          <p:cNvSpPr txBox="1"/>
          <p:nvPr/>
        </p:nvSpPr>
        <p:spPr>
          <a:xfrm>
            <a:off x="3508631" y="2446442"/>
            <a:ext cx="80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Hyperoxi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直接连接符 104">
            <a:extLst>
              <a:ext uri="{FF2B5EF4-FFF2-40B4-BE49-F238E27FC236}">
                <a16:creationId xmlns:a16="http://schemas.microsoft.com/office/drawing/2014/main" id="{0CB0A5F7-FFB1-450F-98E9-BA2D08BF29EC}"/>
              </a:ext>
            </a:extLst>
          </p:cNvPr>
          <p:cNvCxnSpPr/>
          <p:nvPr/>
        </p:nvCxnSpPr>
        <p:spPr>
          <a:xfrm>
            <a:off x="3994552" y="4401466"/>
            <a:ext cx="3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6" name="文本框 105">
            <a:extLst>
              <a:ext uri="{FF2B5EF4-FFF2-40B4-BE49-F238E27FC236}">
                <a16:creationId xmlns:a16="http://schemas.microsoft.com/office/drawing/2014/main" id="{D81177EE-2029-41BC-924B-88FB19D2BE7A}"/>
              </a:ext>
            </a:extLst>
          </p:cNvPr>
          <p:cNvSpPr txBox="1"/>
          <p:nvPr/>
        </p:nvSpPr>
        <p:spPr>
          <a:xfrm>
            <a:off x="3914175" y="4394879"/>
            <a:ext cx="52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r>
              <a:rPr lang="el-GR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1" name="图片 50">
            <a:extLst>
              <a:ext uri="{FF2B5EF4-FFF2-40B4-BE49-F238E27FC236}">
                <a16:creationId xmlns:a16="http://schemas.microsoft.com/office/drawing/2014/main" id="{EFD3859B-5430-4DC9-979E-0E8DEC55D525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55" t="40008" r="46120" b="39144"/>
          <a:stretch/>
        </p:blipFill>
        <p:spPr>
          <a:xfrm>
            <a:off x="1381694" y="2658515"/>
            <a:ext cx="960708" cy="960708"/>
          </a:xfrm>
          <a:prstGeom prst="rect">
            <a:avLst/>
          </a:prstGeom>
        </p:spPr>
      </p:pic>
      <p:pic>
        <p:nvPicPr>
          <p:cNvPr id="63" name="图片 62">
            <a:extLst>
              <a:ext uri="{FF2B5EF4-FFF2-40B4-BE49-F238E27FC236}">
                <a16:creationId xmlns:a16="http://schemas.microsoft.com/office/drawing/2014/main" id="{9BA80B6C-C23D-4FE8-A103-3C6B50F55434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435" t="16090" r="7836" b="63197"/>
          <a:stretch/>
        </p:blipFill>
        <p:spPr>
          <a:xfrm>
            <a:off x="381647" y="3665537"/>
            <a:ext cx="954468" cy="954468"/>
          </a:xfrm>
          <a:prstGeom prst="rect">
            <a:avLst/>
          </a:prstGeom>
        </p:spPr>
      </p:pic>
      <p:pic>
        <p:nvPicPr>
          <p:cNvPr id="67" name="图片 66">
            <a:extLst>
              <a:ext uri="{FF2B5EF4-FFF2-40B4-BE49-F238E27FC236}">
                <a16:creationId xmlns:a16="http://schemas.microsoft.com/office/drawing/2014/main" id="{254135A0-E535-4B62-8B2F-FA833B599979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539" t="17315" r="16636" b="61837"/>
          <a:stretch/>
        </p:blipFill>
        <p:spPr>
          <a:xfrm>
            <a:off x="1381694" y="3663363"/>
            <a:ext cx="960708" cy="960708"/>
          </a:xfrm>
          <a:prstGeom prst="rect">
            <a:avLst/>
          </a:prstGeom>
        </p:spPr>
      </p:pic>
      <p:pic>
        <p:nvPicPr>
          <p:cNvPr id="73" name="图片 72">
            <a:extLst>
              <a:ext uri="{FF2B5EF4-FFF2-40B4-BE49-F238E27FC236}">
                <a16:creationId xmlns:a16="http://schemas.microsoft.com/office/drawing/2014/main" id="{A2BA2BF2-8E08-4362-8BE2-B6BEFE8CCE96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443" t="11962" r="70731" b="67190"/>
          <a:stretch/>
        </p:blipFill>
        <p:spPr>
          <a:xfrm>
            <a:off x="2435108" y="3653225"/>
            <a:ext cx="960709" cy="960709"/>
          </a:xfrm>
          <a:prstGeom prst="rect">
            <a:avLst/>
          </a:prstGeom>
        </p:spPr>
      </p:pic>
      <p:pic>
        <p:nvPicPr>
          <p:cNvPr id="109" name="图片 108">
            <a:extLst>
              <a:ext uri="{FF2B5EF4-FFF2-40B4-BE49-F238E27FC236}">
                <a16:creationId xmlns:a16="http://schemas.microsoft.com/office/drawing/2014/main" id="{89D4565A-E993-4F0B-B178-2BE3BE57CE91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21" t="43497" r="66750" b="35790"/>
          <a:stretch/>
        </p:blipFill>
        <p:spPr>
          <a:xfrm>
            <a:off x="2440149" y="2661634"/>
            <a:ext cx="954468" cy="954468"/>
          </a:xfrm>
          <a:prstGeom prst="rect">
            <a:avLst/>
          </a:prstGeom>
        </p:spPr>
      </p:pic>
      <p:pic>
        <p:nvPicPr>
          <p:cNvPr id="111" name="图片 110">
            <a:extLst>
              <a:ext uri="{FF2B5EF4-FFF2-40B4-BE49-F238E27FC236}">
                <a16:creationId xmlns:a16="http://schemas.microsoft.com/office/drawing/2014/main" id="{47D11E99-F8CE-4184-9808-1711385C6AA3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484" t="31531" r="19787" b="47756"/>
          <a:stretch/>
        </p:blipFill>
        <p:spPr>
          <a:xfrm>
            <a:off x="3436472" y="2655518"/>
            <a:ext cx="954468" cy="954468"/>
          </a:xfrm>
          <a:prstGeom prst="rect">
            <a:avLst/>
          </a:prstGeom>
        </p:spPr>
      </p:pic>
      <p:pic>
        <p:nvPicPr>
          <p:cNvPr id="112" name="图片 111">
            <a:extLst>
              <a:ext uri="{FF2B5EF4-FFF2-40B4-BE49-F238E27FC236}">
                <a16:creationId xmlns:a16="http://schemas.microsoft.com/office/drawing/2014/main" id="{69C24DA9-A800-41D3-84B5-67326FDCF292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372071" y="2758089"/>
            <a:ext cx="2295710" cy="2021596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D23974CC-2DFE-49EA-98C8-1CCA0B747388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9683" y="5201807"/>
            <a:ext cx="2368136" cy="719599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3D576BCC-9D13-4274-AE70-663023AFAD21}"/>
              </a:ext>
            </a:extLst>
          </p:cNvPr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90940" y="4712689"/>
            <a:ext cx="2296800" cy="1520587"/>
          </a:xfrm>
          <a:prstGeom prst="rect">
            <a:avLst/>
          </a:prstGeom>
        </p:spPr>
      </p:pic>
      <p:sp>
        <p:nvSpPr>
          <p:cNvPr id="50" name="文本框 49">
            <a:extLst>
              <a:ext uri="{FF2B5EF4-FFF2-40B4-BE49-F238E27FC236}">
                <a16:creationId xmlns:a16="http://schemas.microsoft.com/office/drawing/2014/main" id="{A8451073-11F5-4FDF-937B-F35B9F232489}"/>
              </a:ext>
            </a:extLst>
          </p:cNvPr>
          <p:cNvSpPr txBox="1"/>
          <p:nvPr/>
        </p:nvSpPr>
        <p:spPr>
          <a:xfrm>
            <a:off x="1509641" y="4890892"/>
            <a:ext cx="660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D206557D-C719-4FCB-9A56-FE3F95A155FD}"/>
              </a:ext>
            </a:extLst>
          </p:cNvPr>
          <p:cNvSpPr txBox="1"/>
          <p:nvPr/>
        </p:nvSpPr>
        <p:spPr>
          <a:xfrm>
            <a:off x="2681067" y="4890892"/>
            <a:ext cx="7326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Hyperoxia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id="{07BF3913-DD6D-45D0-911C-8229A56D8749}"/>
              </a:ext>
            </a:extLst>
          </p:cNvPr>
          <p:cNvCxnSpPr/>
          <p:nvPr/>
        </p:nvCxnSpPr>
        <p:spPr>
          <a:xfrm>
            <a:off x="1252977" y="5077308"/>
            <a:ext cx="11376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790AB2B6-C68E-4373-81FE-BA5B2E71D253}"/>
              </a:ext>
            </a:extLst>
          </p:cNvPr>
          <p:cNvCxnSpPr/>
          <p:nvPr/>
        </p:nvCxnSpPr>
        <p:spPr>
          <a:xfrm>
            <a:off x="2433962" y="5077308"/>
            <a:ext cx="11376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07F21816-A404-4AF5-BC02-80BB357B6BCB}"/>
              </a:ext>
            </a:extLst>
          </p:cNvPr>
          <p:cNvSpPr txBox="1"/>
          <p:nvPr/>
        </p:nvSpPr>
        <p:spPr>
          <a:xfrm>
            <a:off x="1154173" y="5039285"/>
            <a:ext cx="3872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1D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76BAC0D3-C7B6-4F6E-A636-CD9F8232DC60}"/>
              </a:ext>
            </a:extLst>
          </p:cNvPr>
          <p:cNvSpPr txBox="1"/>
          <p:nvPr/>
        </p:nvSpPr>
        <p:spPr>
          <a:xfrm>
            <a:off x="1386732" y="5039285"/>
            <a:ext cx="3872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3D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5AD2C903-05FE-4D0C-8B72-B33C2A4C6CE8}"/>
              </a:ext>
            </a:extLst>
          </p:cNvPr>
          <p:cNvSpPr txBox="1"/>
          <p:nvPr/>
        </p:nvSpPr>
        <p:spPr>
          <a:xfrm>
            <a:off x="1624705" y="5039223"/>
            <a:ext cx="3872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5D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EE9D96B5-05AE-4DE3-8253-E4CAE3275E1A}"/>
              </a:ext>
            </a:extLst>
          </p:cNvPr>
          <p:cNvSpPr txBox="1"/>
          <p:nvPr/>
        </p:nvSpPr>
        <p:spPr>
          <a:xfrm>
            <a:off x="1863737" y="5037527"/>
            <a:ext cx="3872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7D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A93C20EC-861F-40D8-9B04-8DB295080003}"/>
              </a:ext>
            </a:extLst>
          </p:cNvPr>
          <p:cNvSpPr txBox="1"/>
          <p:nvPr/>
        </p:nvSpPr>
        <p:spPr>
          <a:xfrm>
            <a:off x="2068955" y="5037527"/>
            <a:ext cx="4395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14D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6E9487F4-21CC-45E2-A900-0F593F953EB6}"/>
              </a:ext>
            </a:extLst>
          </p:cNvPr>
          <p:cNvSpPr txBox="1"/>
          <p:nvPr/>
        </p:nvSpPr>
        <p:spPr>
          <a:xfrm>
            <a:off x="2335811" y="5038576"/>
            <a:ext cx="3872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1D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AC945E6F-E854-4D40-9EC3-6815FCA42DE1}"/>
              </a:ext>
            </a:extLst>
          </p:cNvPr>
          <p:cNvSpPr txBox="1"/>
          <p:nvPr/>
        </p:nvSpPr>
        <p:spPr>
          <a:xfrm>
            <a:off x="2568370" y="5038576"/>
            <a:ext cx="3872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3D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F358EEB9-2716-4FAC-ABA8-05DED9EE946B}"/>
              </a:ext>
            </a:extLst>
          </p:cNvPr>
          <p:cNvSpPr txBox="1"/>
          <p:nvPr/>
        </p:nvSpPr>
        <p:spPr>
          <a:xfrm>
            <a:off x="2806343" y="5038514"/>
            <a:ext cx="3872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5D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5BDCA27B-7F15-458C-9BC0-8D15BF0DDAB7}"/>
              </a:ext>
            </a:extLst>
          </p:cNvPr>
          <p:cNvSpPr txBox="1"/>
          <p:nvPr/>
        </p:nvSpPr>
        <p:spPr>
          <a:xfrm>
            <a:off x="3054473" y="5036818"/>
            <a:ext cx="3872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7D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09B8E95F-BC20-4112-901E-F4B6C6811196}"/>
              </a:ext>
            </a:extLst>
          </p:cNvPr>
          <p:cNvSpPr txBox="1"/>
          <p:nvPr/>
        </p:nvSpPr>
        <p:spPr>
          <a:xfrm>
            <a:off x="3264240" y="5036818"/>
            <a:ext cx="4395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14D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416C6006-CADF-4AA4-A5ED-3ECC40702050}"/>
              </a:ext>
            </a:extLst>
          </p:cNvPr>
          <p:cNvSpPr txBox="1"/>
          <p:nvPr/>
        </p:nvSpPr>
        <p:spPr>
          <a:xfrm>
            <a:off x="784879" y="5260901"/>
            <a:ext cx="660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9215A839-72F4-4983-BF53-EE25B5E1DA34}"/>
              </a:ext>
            </a:extLst>
          </p:cNvPr>
          <p:cNvSpPr txBox="1"/>
          <p:nvPr/>
        </p:nvSpPr>
        <p:spPr>
          <a:xfrm>
            <a:off x="784879" y="5621836"/>
            <a:ext cx="660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502525A4-1367-4FCA-9DC0-46E311200621}"/>
              </a:ext>
            </a:extLst>
          </p:cNvPr>
          <p:cNvSpPr txBox="1"/>
          <p:nvPr/>
        </p:nvSpPr>
        <p:spPr>
          <a:xfrm>
            <a:off x="625629" y="477152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48613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59</TotalTime>
  <Words>42</Words>
  <Application>Microsoft Office PowerPoint</Application>
  <PresentationFormat>自定义</PresentationFormat>
  <Paragraphs>3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Xuewen</cp:lastModifiedBy>
  <cp:revision>65</cp:revision>
  <dcterms:created xsi:type="dcterms:W3CDTF">2020-09-04T01:35:22Z</dcterms:created>
  <dcterms:modified xsi:type="dcterms:W3CDTF">2020-10-11T16:17:01Z</dcterms:modified>
</cp:coreProperties>
</file>